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winserver16\data\mdcrc\Research%20Server%20General\Research\NGS\Proband\tables%20and%20graphs%20consolidation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/>
              <a:t>Spectrum of mutations in DMD diagnosi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1421740957079158"/>
          <c:y val="0.10454166666666669"/>
          <c:w val="0.54368222044533587"/>
          <c:h val="0.89545833333333358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66CCFF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13C-40C4-BAF4-0B4EFB89F4FB}"/>
              </c:ext>
            </c:extLst>
          </c:dPt>
          <c:dPt>
            <c:idx val="1"/>
            <c:bubble3D val="0"/>
            <c:spPr>
              <a:solidFill>
                <a:srgbClr val="0000FF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13C-40C4-BAF4-0B4EFB89F4FB}"/>
              </c:ext>
            </c:extLst>
          </c:dPt>
          <c:dPt>
            <c:idx val="2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13C-40C4-BAF4-0B4EFB89F4FB}"/>
              </c:ext>
            </c:extLst>
          </c:dPt>
          <c:dPt>
            <c:idx val="3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13C-40C4-BAF4-0B4EFB89F4FB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13C-40C4-BAF4-0B4EFB89F4FB}"/>
              </c:ext>
            </c:extLst>
          </c:dPt>
          <c:dPt>
            <c:idx val="5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13C-40C4-BAF4-0B4EFB89F4FB}"/>
              </c:ext>
            </c:extLst>
          </c:dPt>
          <c:dPt>
            <c:idx val="6"/>
            <c:bubble3D val="0"/>
            <c:spPr>
              <a:solidFill>
                <a:srgbClr val="FFC000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813C-40C4-BAF4-0B4EFB89F4FB}"/>
              </c:ext>
            </c:extLst>
          </c:dPt>
          <c:dLbls>
            <c:dLbl>
              <c:idx val="0"/>
              <c:layout>
                <c:manualLayout>
                  <c:x val="-0.20340159287318008"/>
                  <c:y val="-9.2633177797219787E-2"/>
                </c:manualLayout>
              </c:layout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813C-40C4-BAF4-0B4EFB89F4FB}"/>
                </c:ext>
              </c:extLst>
            </c:dLbl>
            <c:dLbl>
              <c:idx val="3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1" i="0" u="none" strike="noStrike" kern="1200" baseline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7-813C-40C4-BAF4-0B4EFB89F4FB}"/>
                </c:ext>
              </c:extLst>
            </c:dLbl>
            <c:dLbl>
              <c:idx val="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1" i="0" u="none" strike="noStrike" kern="1200" baseline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9-813C-40C4-BAF4-0B4EFB89F4F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C$14:$C$20</c:f>
              <c:strCache>
                <c:ptCount val="7"/>
                <c:pt idx="0">
                  <c:v>DMD-Large deletion (hotspot)</c:v>
                </c:pt>
                <c:pt idx="1">
                  <c:v>DMD-Large deletion (non-hotspot)</c:v>
                </c:pt>
                <c:pt idx="2">
                  <c:v>DMD-Large duplication</c:v>
                </c:pt>
                <c:pt idx="3">
                  <c:v>DMD-Small mutation</c:v>
                </c:pt>
                <c:pt idx="4">
                  <c:v>Other muscular disorders</c:v>
                </c:pt>
                <c:pt idx="5">
                  <c:v>Other disorder</c:v>
                </c:pt>
                <c:pt idx="6">
                  <c:v>No variant </c:v>
                </c:pt>
              </c:strCache>
            </c:strRef>
          </c:cat>
          <c:val>
            <c:numRef>
              <c:f>Sheet2!$D$14:$D$20</c:f>
              <c:numCache>
                <c:formatCode>General</c:formatCode>
                <c:ptCount val="7"/>
                <c:pt idx="0">
                  <c:v>626</c:v>
                </c:pt>
                <c:pt idx="1">
                  <c:v>20</c:v>
                </c:pt>
                <c:pt idx="2">
                  <c:v>73</c:v>
                </c:pt>
                <c:pt idx="3">
                  <c:v>101</c:v>
                </c:pt>
                <c:pt idx="4">
                  <c:v>92</c:v>
                </c:pt>
                <c:pt idx="5">
                  <c:v>37</c:v>
                </c:pt>
                <c:pt idx="6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13C-40C4-BAF4-0B4EFB89F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6792117852738235E-3"/>
          <c:y val="7.9164698162729696E-2"/>
          <c:w val="0.23021110313018112"/>
          <c:h val="0.920835301837270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1247</cdr:x>
      <cdr:y>0.13881</cdr:y>
    </cdr:from>
    <cdr:to>
      <cdr:x>0.33655</cdr:x>
      <cdr:y>0.3244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565824" y="683579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IN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>
            <p:extLst/>
          </p:nvPr>
        </p:nvGraphicFramePr>
        <p:xfrm>
          <a:off x="3646256" y="1585777"/>
          <a:ext cx="7369493" cy="4924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560320" y="727094"/>
            <a:ext cx="778050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anose="020F0502020204030204" pitchFamily="34" charset="0"/>
                <a:cs typeface="Times New Roman" pitchFamily="18" charset="0"/>
              </a:rPr>
              <a:t>S1 Fig: Overview of the mutational spectrum in  961 patients</a:t>
            </a:r>
            <a:endParaRPr kumimoji="0" lang="en-US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-427812" y="205247"/>
            <a:ext cx="471952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US" alt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344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3</cp:revision>
  <dcterms:created xsi:type="dcterms:W3CDTF">2020-01-14T07:41:46Z</dcterms:created>
  <dcterms:modified xsi:type="dcterms:W3CDTF">2020-01-14T07:43:27Z</dcterms:modified>
</cp:coreProperties>
</file>